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A33F1-6229-46EE-A223-68D6668D20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BADFD-99AF-4454-86D3-B5B02F934D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021EF-7CAC-471B-8701-2ECCF64FB1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C6CF4-7090-49C3-9820-300BED85C1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B424B-B74B-4CA7-9C94-96857FB395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C541C-BC4B-495B-B21B-EB7AEF7902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C2821-1FBE-4CD9-BC10-0F5462BF12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1C999-3D78-4237-B8CD-9305B7F48E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DB3B6-10D7-4331-8D28-0CCBB05508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D00C9-BE20-40C8-B0ED-9AA1C801D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B107F-7A48-4BFA-825B-5D6089FE75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6B79D-F8F0-4F73-B578-4022A670E0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50078C-0A65-4D81-99AF-E3399EAEB80B}" type="slidenum">
              <a:rPr b="0" lang="en-NZ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8760" y="141120"/>
            <a:ext cx="8734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Key amino-acid motif at position 90 to 93 in R2R3 domain of 173 MYB transcription factor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rabidops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Rosacea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and other spec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395280" y="620640"/>
            <a:ext cx="4681440" cy="597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8T00:49:31Z</dcterms:created>
  <dc:creator>hraaca</dc:creator>
  <dc:description/>
  <dc:language>en-US</dc:language>
  <cp:lastModifiedBy>hraaca</cp:lastModifiedBy>
  <dcterms:modified xsi:type="dcterms:W3CDTF">2010-02-18T21:21:05Z</dcterms:modified>
  <cp:revision>2</cp:revision>
  <dc:subject/>
  <dc:title>Slide 1</dc:title>
</cp:coreProperties>
</file>